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0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32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53054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81828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40583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82647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70410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769317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22621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8706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18744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03802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71121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4460E-16FB-4ED6-904E-560958B45631}" type="datetimeFigureOut">
              <a:rPr lang="en-IE" smtClean="0"/>
              <a:t>16/05/2019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34EEE-7456-4052-BAAE-70B83B2ADA55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271506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542682" y="33195"/>
            <a:ext cx="6564258" cy="6412814"/>
            <a:chOff x="2542682" y="33195"/>
            <a:chExt cx="6564258" cy="6412814"/>
          </a:xfrm>
        </p:grpSpPr>
        <p:sp>
          <p:nvSpPr>
            <p:cNvPr id="4" name="Text Box 13"/>
            <p:cNvSpPr txBox="1"/>
            <p:nvPr/>
          </p:nvSpPr>
          <p:spPr>
            <a:xfrm>
              <a:off x="4272415" y="33195"/>
              <a:ext cx="3542665" cy="453390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mail invite to PMP women on ULBC database (n = 271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sponders proceeding to bone (DXA) scan (n= 41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 Box 19"/>
            <p:cNvSpPr txBox="1"/>
            <p:nvPr/>
          </p:nvSpPr>
          <p:spPr>
            <a:xfrm>
              <a:off x="3204754" y="774317"/>
              <a:ext cx="1495017" cy="60188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ealthy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MD T-score &gt; -1.0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13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 Box 20"/>
            <p:cNvSpPr txBox="1"/>
            <p:nvPr/>
          </p:nvSpPr>
          <p:spPr>
            <a:xfrm>
              <a:off x="5103813" y="774317"/>
              <a:ext cx="2185262" cy="60188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steopenic 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MD T-score &lt;-1.0 and &gt;-2.5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        Invited to participate (n = 24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 Box 21"/>
            <p:cNvSpPr txBox="1"/>
            <p:nvPr/>
          </p:nvSpPr>
          <p:spPr>
            <a:xfrm>
              <a:off x="7589747" y="774952"/>
              <a:ext cx="1371374" cy="601254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steoporotic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MD T- score ≥-2.5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3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 Box 22"/>
            <p:cNvSpPr txBox="1"/>
            <p:nvPr/>
          </p:nvSpPr>
          <p:spPr>
            <a:xfrm>
              <a:off x="3692483" y="1464765"/>
              <a:ext cx="1596300" cy="41710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eclined to participate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 5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 Box 23"/>
            <p:cNvSpPr txBox="1"/>
            <p:nvPr/>
          </p:nvSpPr>
          <p:spPr>
            <a:xfrm>
              <a:off x="5460275" y="1863027"/>
              <a:ext cx="1698172" cy="410210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oceed to Clinical Screen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19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 Box 34"/>
            <p:cNvSpPr txBox="1"/>
            <p:nvPr/>
          </p:nvSpPr>
          <p:spPr>
            <a:xfrm>
              <a:off x="2998745" y="2248924"/>
              <a:ext cx="2377123" cy="39623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Withdrawn by clinical screen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endronate (n=1); Gabapentin (n=1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 Box 2"/>
            <p:cNvSpPr txBox="1"/>
            <p:nvPr/>
          </p:nvSpPr>
          <p:spPr>
            <a:xfrm>
              <a:off x="5460275" y="2645163"/>
              <a:ext cx="1698172" cy="45202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ligible to proceed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17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 Box 44"/>
            <p:cNvSpPr txBox="1"/>
            <p:nvPr/>
          </p:nvSpPr>
          <p:spPr>
            <a:xfrm>
              <a:off x="3788867" y="3086125"/>
              <a:ext cx="1596300" cy="396196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available to proceed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 1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 Box 45"/>
            <p:cNvSpPr txBox="1"/>
            <p:nvPr/>
          </p:nvSpPr>
          <p:spPr>
            <a:xfrm>
              <a:off x="5460275" y="3469118"/>
              <a:ext cx="1698172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udy participants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algn="ctr">
                <a:spcAft>
                  <a:spcPts val="0"/>
                </a:spcAft>
              </a:pPr>
              <a:r>
                <a:rPr lang="en-IE" sz="11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16)</a:t>
              </a:r>
              <a:endParaRPr lang="en-IE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 Box 45"/>
            <p:cNvSpPr txBox="1"/>
            <p:nvPr/>
          </p:nvSpPr>
          <p:spPr>
            <a:xfrm>
              <a:off x="7178088" y="4112892"/>
              <a:ext cx="1928851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ocated to and received intervention MBPM</a:t>
              </a:r>
              <a:r>
                <a:rPr lang="en-IE" sz="11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 8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 Box 45"/>
            <p:cNvSpPr txBox="1"/>
            <p:nvPr/>
          </p:nvSpPr>
          <p:spPr>
            <a:xfrm>
              <a:off x="3372443" y="4114391"/>
              <a:ext cx="1918565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ocated to and received intervention CON</a:t>
              </a:r>
              <a:r>
                <a:rPr lang="en-IE" sz="11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 8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 Box 45"/>
            <p:cNvSpPr txBox="1"/>
            <p:nvPr/>
          </p:nvSpPr>
          <p:spPr>
            <a:xfrm>
              <a:off x="3372443" y="4678202"/>
              <a:ext cx="1933352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ocated to and received intervention MBPM</a:t>
              </a:r>
              <a:r>
                <a:rPr lang="en-IE" sz="11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 8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 Box 45"/>
            <p:cNvSpPr txBox="1"/>
            <p:nvPr/>
          </p:nvSpPr>
          <p:spPr>
            <a:xfrm>
              <a:off x="7160672" y="4678202"/>
              <a:ext cx="1946268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ocated to and received intervention CON</a:t>
              </a:r>
              <a:r>
                <a:rPr lang="en-IE" sz="11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= 8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 Box 45"/>
            <p:cNvSpPr txBox="1"/>
            <p:nvPr/>
          </p:nvSpPr>
          <p:spPr>
            <a:xfrm>
              <a:off x="3370218" y="5238872"/>
              <a:ext cx="1918565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ost to follow-up </a:t>
              </a:r>
            </a:p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0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 Box 45"/>
            <p:cNvSpPr txBox="1"/>
            <p:nvPr/>
          </p:nvSpPr>
          <p:spPr>
            <a:xfrm>
              <a:off x="7156313" y="5262785"/>
              <a:ext cx="1946269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ost to follow-up </a:t>
              </a:r>
            </a:p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0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 Box 45"/>
            <p:cNvSpPr txBox="1"/>
            <p:nvPr/>
          </p:nvSpPr>
          <p:spPr>
            <a:xfrm>
              <a:off x="3370218" y="5804742"/>
              <a:ext cx="1928852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ysed</a:t>
              </a:r>
              <a:r>
                <a:rPr lang="en-IE" sz="11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16)</a:t>
              </a:r>
            </a:p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cluded from analysis (n=0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1137483" y="1504483"/>
              <a:ext cx="3091978" cy="276999"/>
            </a:xfrm>
            <a:prstGeom prst="rect">
              <a:avLst/>
            </a:prstGeom>
            <a:solidFill>
              <a:schemeClr val="bg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IE" sz="1200" b="1" dirty="0" smtClean="0"/>
                <a:t>   Enrolment                                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1937105" y="3887362"/>
              <a:ext cx="1492736" cy="276999"/>
            </a:xfrm>
            <a:prstGeom prst="rect">
              <a:avLst/>
            </a:prstGeom>
            <a:solidFill>
              <a:schemeClr val="bg2"/>
            </a:solidFill>
          </p:spPr>
          <p:txBody>
            <a:bodyPr wrap="square" rtlCol="0">
              <a:spAutoFit/>
            </a:bodyPr>
            <a:lstStyle/>
            <a:p>
              <a:r>
                <a:rPr lang="en-IE" sz="1200" b="1" dirty="0" smtClean="0"/>
                <a:t>         Allocation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2328040" y="5954367"/>
              <a:ext cx="706284" cy="276999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rtlCol="0">
              <a:spAutoFit/>
            </a:bodyPr>
            <a:lstStyle/>
            <a:p>
              <a:r>
                <a:rPr lang="en-IE" sz="1200" b="1" dirty="0" smtClean="0"/>
                <a:t>Analysis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2270374" y="5136897"/>
              <a:ext cx="825291" cy="276999"/>
            </a:xfrm>
            <a:prstGeom prst="rect">
              <a:avLst/>
            </a:prstGeom>
            <a:solidFill>
              <a:schemeClr val="bg2"/>
            </a:solidFill>
          </p:spPr>
          <p:txBody>
            <a:bodyPr wrap="none" rtlCol="0">
              <a:spAutoFit/>
            </a:bodyPr>
            <a:lstStyle/>
            <a:p>
              <a:r>
                <a:rPr lang="en-IE" sz="1200" b="1" dirty="0" smtClean="0"/>
                <a:t>Follow-up</a:t>
              </a:r>
            </a:p>
          </p:txBody>
        </p:sp>
        <p:cxnSp>
          <p:nvCxnSpPr>
            <p:cNvPr id="39" name="Straight Arrow Connector 38"/>
            <p:cNvCxnSpPr/>
            <p:nvPr/>
          </p:nvCxnSpPr>
          <p:spPr>
            <a:xfrm flipH="1">
              <a:off x="6043747" y="495092"/>
              <a:ext cx="2" cy="27655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>
              <a:stCxn id="17" idx="2"/>
            </p:cNvCxnSpPr>
            <p:nvPr/>
          </p:nvCxnSpPr>
          <p:spPr>
            <a:xfrm>
              <a:off x="6196444" y="1376206"/>
              <a:ext cx="0" cy="48682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>
              <a:off x="6198735" y="2275908"/>
              <a:ext cx="0" cy="36925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>
              <a:off x="6196444" y="3113066"/>
              <a:ext cx="0" cy="36925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H="1">
              <a:off x="5288783" y="1637711"/>
              <a:ext cx="907661" cy="932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>
              <a:endCxn id="23" idx="3"/>
            </p:cNvCxnSpPr>
            <p:nvPr/>
          </p:nvCxnSpPr>
          <p:spPr>
            <a:xfrm flipH="1">
              <a:off x="5385167" y="3279493"/>
              <a:ext cx="811277" cy="473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>
              <a:endCxn id="21" idx="3"/>
            </p:cNvCxnSpPr>
            <p:nvPr/>
          </p:nvCxnSpPr>
          <p:spPr>
            <a:xfrm flipH="1">
              <a:off x="5375868" y="2438652"/>
              <a:ext cx="805651" cy="839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7" name="Group 66"/>
            <p:cNvGrpSpPr/>
            <p:nvPr/>
          </p:nvGrpSpPr>
          <p:grpSpPr>
            <a:xfrm>
              <a:off x="4153989" y="533591"/>
              <a:ext cx="3988525" cy="152681"/>
              <a:chOff x="4153989" y="533591"/>
              <a:chExt cx="3988525" cy="152681"/>
            </a:xfrm>
          </p:grpSpPr>
          <p:cxnSp>
            <p:nvCxnSpPr>
              <p:cNvPr id="58" name="Straight Connector 57"/>
              <p:cNvCxnSpPr/>
              <p:nvPr/>
            </p:nvCxnSpPr>
            <p:spPr>
              <a:xfrm>
                <a:off x="4153989" y="537887"/>
                <a:ext cx="3988525" cy="1782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Arrow Connector 59"/>
              <p:cNvCxnSpPr/>
              <p:nvPr/>
            </p:nvCxnSpPr>
            <p:spPr>
              <a:xfrm flipH="1">
                <a:off x="4153989" y="533591"/>
                <a:ext cx="1" cy="13153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/>
              <p:cNvCxnSpPr/>
              <p:nvPr/>
            </p:nvCxnSpPr>
            <p:spPr>
              <a:xfrm flipH="1">
                <a:off x="8129448" y="554736"/>
                <a:ext cx="1" cy="13153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Group 67"/>
            <p:cNvGrpSpPr/>
            <p:nvPr/>
          </p:nvGrpSpPr>
          <p:grpSpPr>
            <a:xfrm>
              <a:off x="4272415" y="3983555"/>
              <a:ext cx="3692432" cy="165084"/>
              <a:chOff x="4153989" y="533591"/>
              <a:chExt cx="3988525" cy="152681"/>
            </a:xfrm>
          </p:grpSpPr>
          <p:cxnSp>
            <p:nvCxnSpPr>
              <p:cNvPr id="69" name="Straight Connector 68"/>
              <p:cNvCxnSpPr/>
              <p:nvPr/>
            </p:nvCxnSpPr>
            <p:spPr>
              <a:xfrm>
                <a:off x="4153989" y="537887"/>
                <a:ext cx="3988525" cy="1782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Arrow Connector 69"/>
              <p:cNvCxnSpPr/>
              <p:nvPr/>
            </p:nvCxnSpPr>
            <p:spPr>
              <a:xfrm flipH="1">
                <a:off x="4153989" y="533591"/>
                <a:ext cx="1" cy="13153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/>
              <p:cNvCxnSpPr/>
              <p:nvPr/>
            </p:nvCxnSpPr>
            <p:spPr>
              <a:xfrm flipH="1">
                <a:off x="8129448" y="554736"/>
                <a:ext cx="1" cy="131536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2" name="Straight Arrow Connector 71"/>
            <p:cNvCxnSpPr/>
            <p:nvPr/>
          </p:nvCxnSpPr>
          <p:spPr>
            <a:xfrm flipH="1">
              <a:off x="6196444" y="3883227"/>
              <a:ext cx="1" cy="1315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Arrow Connector 72"/>
            <p:cNvCxnSpPr/>
            <p:nvPr/>
          </p:nvCxnSpPr>
          <p:spPr>
            <a:xfrm flipH="1">
              <a:off x="8038009" y="5129832"/>
              <a:ext cx="1" cy="1315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Arrow Connector 73"/>
            <p:cNvCxnSpPr/>
            <p:nvPr/>
          </p:nvCxnSpPr>
          <p:spPr>
            <a:xfrm flipH="1">
              <a:off x="4272415" y="5119793"/>
              <a:ext cx="1" cy="1315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/>
            <p:cNvCxnSpPr/>
            <p:nvPr/>
          </p:nvCxnSpPr>
          <p:spPr>
            <a:xfrm flipH="1">
              <a:off x="4272414" y="5672890"/>
              <a:ext cx="1" cy="1315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 Box 45"/>
            <p:cNvSpPr txBox="1"/>
            <p:nvPr/>
          </p:nvSpPr>
          <p:spPr>
            <a:xfrm>
              <a:off x="7178088" y="5810483"/>
              <a:ext cx="1928852" cy="41410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nalysed</a:t>
              </a:r>
              <a:r>
                <a:rPr lang="en-IE" sz="11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IE" sz="11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16)</a:t>
              </a:r>
            </a:p>
            <a:p>
              <a:pPr algn="ctr">
                <a:spcAft>
                  <a:spcPts val="0"/>
                </a:spcAft>
              </a:pPr>
              <a:r>
                <a:rPr lang="en-IE" sz="11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cluded from analysis (n=0)</a:t>
              </a:r>
              <a:endParaRPr lang="en-IE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7" name="Straight Arrow Connector 76"/>
            <p:cNvCxnSpPr/>
            <p:nvPr/>
          </p:nvCxnSpPr>
          <p:spPr>
            <a:xfrm flipH="1">
              <a:off x="8080284" y="5678631"/>
              <a:ext cx="1" cy="1315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/>
            <p:cNvCxnSpPr>
              <a:stCxn id="26" idx="3"/>
              <a:endCxn id="28" idx="1"/>
            </p:cNvCxnSpPr>
            <p:nvPr/>
          </p:nvCxnSpPr>
          <p:spPr>
            <a:xfrm>
              <a:off x="5291008" y="4321446"/>
              <a:ext cx="1869664" cy="56381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Arrow Connector 80"/>
            <p:cNvCxnSpPr>
              <a:stCxn id="25" idx="1"/>
              <a:endCxn id="27" idx="3"/>
            </p:cNvCxnSpPr>
            <p:nvPr/>
          </p:nvCxnSpPr>
          <p:spPr>
            <a:xfrm flipH="1">
              <a:off x="5305795" y="4319947"/>
              <a:ext cx="1872293" cy="56531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96660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98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Limeric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.Jakeman</dc:creator>
  <cp:lastModifiedBy>Phil.Jakeman</cp:lastModifiedBy>
  <cp:revision>9</cp:revision>
  <dcterms:created xsi:type="dcterms:W3CDTF">2019-05-16T02:37:13Z</dcterms:created>
  <dcterms:modified xsi:type="dcterms:W3CDTF">2019-05-16T15:21:56Z</dcterms:modified>
</cp:coreProperties>
</file>